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9144000" type="letter"/>
  <p:notesSz cx="6985000" cy="92837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Xiaosong" initials="WX" lastIdx="15" clrIdx="0">
    <p:extLst>
      <p:ext uri="{19B8F6BF-5375-455C-9EA6-DF929625EA0E}">
        <p15:presenceInfo xmlns:p15="http://schemas.microsoft.com/office/powerpoint/2012/main" userId="S-1-5-21-3638902971-2991412078-595165587-1001" providerId="AD"/>
      </p:ext>
    </p:extLst>
  </p:cmAuthor>
  <p:cmAuthor id="2" name="Wang, Xiaosong" initials="WX [2]" lastIdx="6" clrIdx="1">
    <p:extLst>
      <p:ext uri="{19B8F6BF-5375-455C-9EA6-DF929625EA0E}">
        <p15:presenceInfo xmlns:p15="http://schemas.microsoft.com/office/powerpoint/2012/main" userId="Wang, Xiaoson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AF018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19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5797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3C133FDB-C86D-474B-9D9A-05281838F995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9338" y="1160463"/>
            <a:ext cx="2346325" cy="31321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780"/>
            <a:ext cx="5588000" cy="3655457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5"/>
            <a:ext cx="3026833" cy="465796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8867E93F-A43C-471B-85D3-9478BE52FA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76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356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3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563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69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334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734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7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070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967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965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9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11D9-8FAD-4F34-9B58-456AAC88BCB8}" type="datetimeFigureOut">
              <a:rPr lang="en-US" smtClean="0"/>
              <a:t>4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3287-86B2-4841-96CF-14369F8BCA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56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文本框 13">
            <a:extLst>
              <a:ext uri="{FF2B5EF4-FFF2-40B4-BE49-F238E27FC236}">
                <a16:creationId xmlns:a16="http://schemas.microsoft.com/office/drawing/2014/main" id="{C2797EB8-62AD-4BE7-A07F-DCED684B8F41}"/>
              </a:ext>
            </a:extLst>
          </p:cNvPr>
          <p:cNvSpPr txBox="1"/>
          <p:nvPr/>
        </p:nvSpPr>
        <p:spPr>
          <a:xfrm>
            <a:off x="512268" y="3221856"/>
            <a:ext cx="59788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rifying the efficiency of E2-E10 siRNA in HCC1428 cells and its effect on ESR1 and HER2 mRNA expression.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estern blot detecting the efficiency of E2-E10-siRNA silencing in HCC1428 cell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T-PCR result showing the mRNA expression of ESR1 and HER2 in the HCC1428 cells treated with 4-OH tamoxifen (0.5μM) or fulvestrant (0.1μM), with or without E2-E10 depletion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C17543F-3480-46EA-93C6-BBA422F8DF87}"/>
              </a:ext>
            </a:extLst>
          </p:cNvPr>
          <p:cNvSpPr txBox="1"/>
          <p:nvPr/>
        </p:nvSpPr>
        <p:spPr>
          <a:xfrm>
            <a:off x="1098804" y="118671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A4C749B-9EF3-4F0E-9A32-DFDBD83EE1C8}"/>
              </a:ext>
            </a:extLst>
          </p:cNvPr>
          <p:cNvSpPr txBox="1"/>
          <p:nvPr/>
        </p:nvSpPr>
        <p:spPr>
          <a:xfrm>
            <a:off x="2893107" y="120395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42810A2-13D0-4193-A09B-D693DF0E68CF}"/>
              </a:ext>
            </a:extLst>
          </p:cNvPr>
          <p:cNvGrpSpPr/>
          <p:nvPr/>
        </p:nvGrpSpPr>
        <p:grpSpPr>
          <a:xfrm>
            <a:off x="3595697" y="1185056"/>
            <a:ext cx="1540667" cy="1566690"/>
            <a:chOff x="3595697" y="1185056"/>
            <a:chExt cx="1540667" cy="156669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6541FAC-B5BB-42F4-B068-E664147CA2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49574" y="1989607"/>
              <a:ext cx="986789" cy="19704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3D16D91E-7C4B-4F4E-B620-05EEDD9BE538}"/>
                </a:ext>
              </a:extLst>
            </p:cNvPr>
            <p:cNvGrpSpPr/>
            <p:nvPr/>
          </p:nvGrpSpPr>
          <p:grpSpPr>
            <a:xfrm>
              <a:off x="3595697" y="1185056"/>
              <a:ext cx="1540667" cy="1566690"/>
              <a:chOff x="3595697" y="1185056"/>
              <a:chExt cx="1540667" cy="1566690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71087499-978D-48A3-A99F-11A1E39D936C}"/>
                  </a:ext>
                </a:extLst>
              </p:cNvPr>
              <p:cNvGrpSpPr/>
              <p:nvPr/>
            </p:nvGrpSpPr>
            <p:grpSpPr>
              <a:xfrm>
                <a:off x="3595697" y="1185056"/>
                <a:ext cx="1537780" cy="1562457"/>
                <a:chOff x="2906101" y="1257258"/>
                <a:chExt cx="1537780" cy="1562457"/>
              </a:xfrm>
            </p:grpSpPr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C62AE6CB-8DA6-4A04-B9AD-E6758CC3DFA3}"/>
                    </a:ext>
                  </a:extLst>
                </p:cNvPr>
                <p:cNvGrpSpPr/>
                <p:nvPr/>
              </p:nvGrpSpPr>
              <p:grpSpPr>
                <a:xfrm>
                  <a:off x="2906101" y="1257258"/>
                  <a:ext cx="1537780" cy="1562457"/>
                  <a:chOff x="2906101" y="1257258"/>
                  <a:chExt cx="1537780" cy="1562457"/>
                </a:xfrm>
              </p:grpSpPr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325CAEDE-7815-4B91-97A6-DE99B4B780F3}"/>
                      </a:ext>
                    </a:extLst>
                  </p:cNvPr>
                  <p:cNvSpPr txBox="1"/>
                  <p:nvPr/>
                </p:nvSpPr>
                <p:spPr>
                  <a:xfrm>
                    <a:off x="2906101" y="2588883"/>
                    <a:ext cx="665807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/>
                      <a:t>GAPDH</a:t>
                    </a:r>
                  </a:p>
                </p:txBody>
              </p:sp>
              <p:grpSp>
                <p:nvGrpSpPr>
                  <p:cNvPr id="3" name="组合 2"/>
                  <p:cNvGrpSpPr/>
                  <p:nvPr/>
                </p:nvGrpSpPr>
                <p:grpSpPr>
                  <a:xfrm>
                    <a:off x="2940799" y="1257258"/>
                    <a:ext cx="1503082" cy="1294941"/>
                    <a:chOff x="3251290" y="2241340"/>
                    <a:chExt cx="1503082" cy="1294941"/>
                  </a:xfrm>
                </p:grpSpPr>
                <p:grpSp>
                  <p:nvGrpSpPr>
                    <p:cNvPr id="79" name="组合 78"/>
                    <p:cNvGrpSpPr/>
                    <p:nvPr/>
                  </p:nvGrpSpPr>
                  <p:grpSpPr>
                    <a:xfrm>
                      <a:off x="3251290" y="2241340"/>
                      <a:ext cx="1503082" cy="1294941"/>
                      <a:chOff x="1226622" y="3064017"/>
                      <a:chExt cx="1503082" cy="1294941"/>
                    </a:xfrm>
                  </p:grpSpPr>
                  <p:sp>
                    <p:nvSpPr>
                      <p:cNvPr id="80" name="TextBox 34"/>
                      <p:cNvSpPr txBox="1"/>
                      <p:nvPr/>
                    </p:nvSpPr>
                    <p:spPr>
                      <a:xfrm>
                        <a:off x="1576997" y="3064561"/>
                        <a:ext cx="573390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Vehicle</a:t>
                        </a:r>
                      </a:p>
                    </p:txBody>
                  </p:sp>
                  <p:sp>
                    <p:nvSpPr>
                      <p:cNvPr id="81" name="TextBox 35"/>
                      <p:cNvSpPr txBox="1"/>
                      <p:nvPr/>
                    </p:nvSpPr>
                    <p:spPr>
                      <a:xfrm>
                        <a:off x="1988332" y="3064017"/>
                        <a:ext cx="46036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Tam</a:t>
                        </a:r>
                      </a:p>
                    </p:txBody>
                  </p:sp>
                  <p:sp>
                    <p:nvSpPr>
                      <p:cNvPr id="82" name="TextBox 36"/>
                      <p:cNvSpPr txBox="1"/>
                      <p:nvPr/>
                    </p:nvSpPr>
                    <p:spPr>
                      <a:xfrm>
                        <a:off x="2349460" y="3064017"/>
                        <a:ext cx="380244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900" dirty="0" err="1"/>
                          <a:t>Ful</a:t>
                        </a:r>
                        <a:endParaRPr lang="en-US" sz="900" dirty="0"/>
                      </a:p>
                    </p:txBody>
                  </p:sp>
                  <p:grpSp>
                    <p:nvGrpSpPr>
                      <p:cNvPr id="83" name="组合 82"/>
                      <p:cNvGrpSpPr/>
                      <p:nvPr/>
                    </p:nvGrpSpPr>
                    <p:grpSpPr>
                      <a:xfrm>
                        <a:off x="1226622" y="3194276"/>
                        <a:ext cx="1499470" cy="1164682"/>
                        <a:chOff x="1226622" y="3194276"/>
                        <a:chExt cx="1499470" cy="1164682"/>
                      </a:xfrm>
                    </p:grpSpPr>
                    <p:grpSp>
                      <p:nvGrpSpPr>
                        <p:cNvPr id="84" name="组合 83"/>
                        <p:cNvGrpSpPr/>
                        <p:nvPr/>
                      </p:nvGrpSpPr>
                      <p:grpSpPr>
                        <a:xfrm>
                          <a:off x="1674181" y="3194276"/>
                          <a:ext cx="1051911" cy="657634"/>
                          <a:chOff x="1674181" y="3194276"/>
                          <a:chExt cx="1051911" cy="657634"/>
                        </a:xfrm>
                      </p:grpSpPr>
                      <p:sp>
                        <p:nvSpPr>
                          <p:cNvPr id="92" name="TextBox 28"/>
                          <p:cNvSpPr txBox="1"/>
                          <p:nvPr/>
                        </p:nvSpPr>
                        <p:spPr>
                          <a:xfrm rot="16200000">
                            <a:off x="1505331" y="3451821"/>
                            <a:ext cx="568532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900" dirty="0" err="1"/>
                              <a:t>siCtrl</a:t>
                            </a:r>
                            <a:endParaRPr lang="en-US" sz="900" dirty="0"/>
                          </a:p>
                        </p:txBody>
                      </p:sp>
                      <p:sp>
                        <p:nvSpPr>
                          <p:cNvPr id="93" name="TextBox 29"/>
                          <p:cNvSpPr txBox="1"/>
                          <p:nvPr/>
                        </p:nvSpPr>
                        <p:spPr>
                          <a:xfrm rot="16200000">
                            <a:off x="1661961" y="3410123"/>
                            <a:ext cx="652743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dirty="0"/>
                              <a:t>siE2-E10</a:t>
                            </a:r>
                          </a:p>
                        </p:txBody>
                      </p:sp>
                      <p:sp>
                        <p:nvSpPr>
                          <p:cNvPr id="94" name="TextBox 30"/>
                          <p:cNvSpPr txBox="1"/>
                          <p:nvPr/>
                        </p:nvSpPr>
                        <p:spPr>
                          <a:xfrm rot="16200000">
                            <a:off x="1911052" y="3509984"/>
                            <a:ext cx="447558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dirty="0" err="1"/>
                              <a:t>siCtrl</a:t>
                            </a:r>
                            <a:endParaRPr lang="en-US" sz="900" dirty="0"/>
                          </a:p>
                        </p:txBody>
                      </p:sp>
                      <p:sp>
                        <p:nvSpPr>
                          <p:cNvPr id="95" name="TextBox 31"/>
                          <p:cNvSpPr txBox="1"/>
                          <p:nvPr/>
                        </p:nvSpPr>
                        <p:spPr>
                          <a:xfrm rot="16200000">
                            <a:off x="2225740" y="3507825"/>
                            <a:ext cx="447558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dirty="0" err="1"/>
                              <a:t>siCtrl</a:t>
                            </a:r>
                            <a:endParaRPr lang="en-US" sz="900" dirty="0"/>
                          </a:p>
                        </p:txBody>
                      </p:sp>
                      <p:sp>
                        <p:nvSpPr>
                          <p:cNvPr id="96" name="TextBox 32"/>
                          <p:cNvSpPr txBox="1"/>
                          <p:nvPr/>
                        </p:nvSpPr>
                        <p:spPr>
                          <a:xfrm rot="16200000">
                            <a:off x="1983683" y="3409903"/>
                            <a:ext cx="652743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dirty="0"/>
                              <a:t>siE2-E10</a:t>
                            </a:r>
                          </a:p>
                        </p:txBody>
                      </p:sp>
                      <p:sp>
                        <p:nvSpPr>
                          <p:cNvPr id="97" name="TextBox 33"/>
                          <p:cNvSpPr txBox="1"/>
                          <p:nvPr/>
                        </p:nvSpPr>
                        <p:spPr>
                          <a:xfrm rot="16200000">
                            <a:off x="2284304" y="3405232"/>
                            <a:ext cx="652743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dirty="0"/>
                              <a:t>siE2-E10</a:t>
                            </a:r>
                          </a:p>
                        </p:txBody>
                      </p:sp>
                    </p:grpSp>
                    <p:sp>
                      <p:nvSpPr>
                        <p:cNvPr id="88" name="TextBox 41"/>
                        <p:cNvSpPr txBox="1"/>
                        <p:nvPr/>
                      </p:nvSpPr>
                      <p:spPr>
                        <a:xfrm>
                          <a:off x="1226622" y="4128126"/>
                          <a:ext cx="562975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ERBB2</a:t>
                          </a:r>
                        </a:p>
                      </p:txBody>
                    </p:sp>
                    <p:sp>
                      <p:nvSpPr>
                        <p:cNvPr id="51" name="TextBox 41">
                          <a:extLst>
                            <a:ext uri="{FF2B5EF4-FFF2-40B4-BE49-F238E27FC236}">
                              <a16:creationId xmlns:a16="http://schemas.microsoft.com/office/drawing/2014/main" id="{03ED5891-AB3B-488C-B8CD-63B1537C50D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81813" y="3849470"/>
                          <a:ext cx="48603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ESR1</a:t>
                          </a:r>
                        </a:p>
                      </p:txBody>
                    </p:sp>
                  </p:grpSp>
                </p:grpSp>
                <p:cxnSp>
                  <p:nvCxnSpPr>
                    <p:cNvPr id="100" name="Straight Connector 57"/>
                    <p:cNvCxnSpPr>
                      <a:cxnSpLocks/>
                    </p:cNvCxnSpPr>
                    <p:nvPr/>
                  </p:nvCxnSpPr>
                  <p:spPr>
                    <a:xfrm>
                      <a:off x="4454879" y="2429801"/>
                      <a:ext cx="19012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cxnSp>
              <p:nvCxnSpPr>
                <p:cNvPr id="56" name="Straight Connector 57">
                  <a:extLst>
                    <a:ext uri="{FF2B5EF4-FFF2-40B4-BE49-F238E27FC236}">
                      <a16:creationId xmlns:a16="http://schemas.microsoft.com/office/drawing/2014/main" id="{91C61ED0-7A3F-4671-B49E-0B9C2E8D39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826844" y="1444305"/>
                  <a:ext cx="19012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Straight Connector 57">
                  <a:extLst>
                    <a:ext uri="{FF2B5EF4-FFF2-40B4-BE49-F238E27FC236}">
                      <a16:creationId xmlns:a16="http://schemas.microsoft.com/office/drawing/2014/main" id="{8C0FDA59-068B-4DBB-9E1A-414CF40EBAA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24129" y="1444760"/>
                  <a:ext cx="19012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6922061B-44FD-43A8-BCCD-8631D19BD1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3539" b="15389"/>
              <a:stretch/>
            </p:blipFill>
            <p:spPr>
              <a:xfrm>
                <a:off x="4149574" y="2244437"/>
                <a:ext cx="986790" cy="24532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0C8D89E0-9EDD-4782-B916-7352F48EE7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45001" y="2539148"/>
                <a:ext cx="991362" cy="21259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5729DA6D-011D-437E-B9C5-974BF60B93FD}"/>
              </a:ext>
            </a:extLst>
          </p:cNvPr>
          <p:cNvGrpSpPr/>
          <p:nvPr/>
        </p:nvGrpSpPr>
        <p:grpSpPr>
          <a:xfrm>
            <a:off x="1228134" y="1350152"/>
            <a:ext cx="1480293" cy="1329381"/>
            <a:chOff x="1518287" y="2803711"/>
            <a:chExt cx="1480293" cy="1329381"/>
          </a:xfrm>
        </p:grpSpPr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F4DB482E-476F-44A4-A0B1-36B38AE6562B}"/>
                </a:ext>
              </a:extLst>
            </p:cNvPr>
            <p:cNvGrpSpPr/>
            <p:nvPr/>
          </p:nvGrpSpPr>
          <p:grpSpPr>
            <a:xfrm>
              <a:off x="2070257" y="2803711"/>
              <a:ext cx="407670" cy="1321731"/>
              <a:chOff x="4806973" y="3703991"/>
              <a:chExt cx="407670" cy="1321731"/>
            </a:xfrm>
          </p:grpSpPr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D7CA0783-F20A-4E5C-9996-F2F93EEB54C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923" t="43476" r="47807" b="51357"/>
              <a:stretch/>
            </p:blipFill>
            <p:spPr>
              <a:xfrm>
                <a:off x="4809008" y="4794889"/>
                <a:ext cx="405635" cy="23083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69D661D-8BCA-4FEA-9E0B-D99ABA397FA6}"/>
                  </a:ext>
                </a:extLst>
              </p:cNvPr>
              <p:cNvSpPr txBox="1"/>
              <p:nvPr/>
            </p:nvSpPr>
            <p:spPr>
              <a:xfrm rot="16200000">
                <a:off x="4525271" y="4077831"/>
                <a:ext cx="79423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 err="1"/>
                  <a:t>siCtrl</a:t>
                </a:r>
                <a:endParaRPr lang="en-US" sz="900" dirty="0"/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C136C838-637A-490B-B7AC-0580A36FE238}"/>
                  </a:ext>
                </a:extLst>
              </p:cNvPr>
              <p:cNvSpPr txBox="1"/>
              <p:nvPr/>
            </p:nvSpPr>
            <p:spPr>
              <a:xfrm rot="16200000">
                <a:off x="4644325" y="4031762"/>
                <a:ext cx="88637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/>
                  <a:t>siE2-E10</a:t>
                </a:r>
              </a:p>
            </p:txBody>
          </p: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7741118-DA55-4127-98F4-9FA3FA799608}"/>
                </a:ext>
              </a:extLst>
            </p:cNvPr>
            <p:cNvSpPr txBox="1"/>
            <p:nvPr/>
          </p:nvSpPr>
          <p:spPr>
            <a:xfrm>
              <a:off x="1518288" y="3690164"/>
              <a:ext cx="6176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E2-E1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4BB743AD-961C-4E5D-953B-6FAE716E57EC}"/>
                </a:ext>
              </a:extLst>
            </p:cNvPr>
            <p:cNvSpPr txBox="1"/>
            <p:nvPr/>
          </p:nvSpPr>
          <p:spPr>
            <a:xfrm>
              <a:off x="1518287" y="3902260"/>
              <a:ext cx="6658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GAPDH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C7553431-55BB-4F6A-BA50-00CBEC643288}"/>
                </a:ext>
              </a:extLst>
            </p:cNvPr>
            <p:cNvSpPr txBox="1"/>
            <p:nvPr/>
          </p:nvSpPr>
          <p:spPr>
            <a:xfrm>
              <a:off x="2441019" y="3424287"/>
              <a:ext cx="5575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/>
                <a:t>kDa</a:t>
              </a:r>
              <a:endParaRPr lang="en-US" sz="900" dirty="0"/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5AF26E4A-B5E9-4F32-88FA-3B63DB977079}"/>
                </a:ext>
              </a:extLst>
            </p:cNvPr>
            <p:cNvCxnSpPr>
              <a:cxnSpLocks/>
            </p:cNvCxnSpPr>
            <p:nvPr/>
          </p:nvCxnSpPr>
          <p:spPr>
            <a:xfrm>
              <a:off x="2463820" y="3794162"/>
              <a:ext cx="1270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7E631074-8A44-40E9-A557-659F6A3E9E21}"/>
                </a:ext>
              </a:extLst>
            </p:cNvPr>
            <p:cNvCxnSpPr>
              <a:cxnSpLocks/>
            </p:cNvCxnSpPr>
            <p:nvPr/>
          </p:nvCxnSpPr>
          <p:spPr>
            <a:xfrm>
              <a:off x="2471257" y="4002317"/>
              <a:ext cx="12703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856E94F-F74C-4A2F-88B5-25B23AA3EF6F}"/>
                </a:ext>
              </a:extLst>
            </p:cNvPr>
            <p:cNvSpPr txBox="1"/>
            <p:nvPr/>
          </p:nvSpPr>
          <p:spPr>
            <a:xfrm>
              <a:off x="2518321" y="3678746"/>
              <a:ext cx="3588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14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D3A2533-1419-4C15-9C22-AAF32E766CD3}"/>
                </a:ext>
              </a:extLst>
            </p:cNvPr>
            <p:cNvSpPr txBox="1"/>
            <p:nvPr/>
          </p:nvSpPr>
          <p:spPr>
            <a:xfrm>
              <a:off x="2540363" y="3886901"/>
              <a:ext cx="3588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37</a:t>
              </a:r>
            </a:p>
          </p:txBody>
        </p:sp>
        <p:pic>
          <p:nvPicPr>
            <p:cNvPr id="63" name="Picture 62">
              <a:extLst>
                <a:ext uri="{FF2B5EF4-FFF2-40B4-BE49-F238E27FC236}">
                  <a16:creationId xmlns:a16="http://schemas.microsoft.com/office/drawing/2014/main" id="{E6F289C3-50AA-44BE-89A3-9F36BE9EDD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1" t="-3135" r="1329" b="3488"/>
            <a:stretch/>
          </p:blipFill>
          <p:spPr>
            <a:xfrm>
              <a:off x="2074127" y="3624147"/>
              <a:ext cx="403800" cy="2308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3209600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05</TotalTime>
  <Words>92</Words>
  <Application>Microsoft Office PowerPoint</Application>
  <PresentationFormat>信纸(8.5x11 英寸)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黑体</vt:lpstr>
      <vt:lpstr>Arial</vt:lpstr>
      <vt:lpstr>Calibri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Xiaosong</dc:creator>
  <cp:lastModifiedBy>李 莉</cp:lastModifiedBy>
  <cp:revision>336</cp:revision>
  <cp:lastPrinted>2019-07-15T22:05:44Z</cp:lastPrinted>
  <dcterms:created xsi:type="dcterms:W3CDTF">2018-01-29T15:22:56Z</dcterms:created>
  <dcterms:modified xsi:type="dcterms:W3CDTF">2020-04-08T14:21:26Z</dcterms:modified>
</cp:coreProperties>
</file>